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98" d="100"/>
          <a:sy n="98" d="100"/>
        </p:scale>
        <p:origin x="-576" y="3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F1C98-A212-4FDB-87EE-485270A6DD90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6FA6-5C13-4166-9B2A-3C30B8A080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0778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F1C98-A212-4FDB-87EE-485270A6DD90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6FA6-5C13-4166-9B2A-3C30B8A080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58246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F1C98-A212-4FDB-87EE-485270A6DD90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6FA6-5C13-4166-9B2A-3C30B8A080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687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F1C98-A212-4FDB-87EE-485270A6DD90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6FA6-5C13-4166-9B2A-3C30B8A080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44323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F1C98-A212-4FDB-87EE-485270A6DD90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6FA6-5C13-4166-9B2A-3C30B8A080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4651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F1C98-A212-4FDB-87EE-485270A6DD90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6FA6-5C13-4166-9B2A-3C30B8A080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5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F1C98-A212-4FDB-87EE-485270A6DD90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6FA6-5C13-4166-9B2A-3C30B8A080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7962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F1C98-A212-4FDB-87EE-485270A6DD90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6FA6-5C13-4166-9B2A-3C30B8A080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2994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F1C98-A212-4FDB-87EE-485270A6DD90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6FA6-5C13-4166-9B2A-3C30B8A080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55217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F1C98-A212-4FDB-87EE-485270A6DD90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6FA6-5C13-4166-9B2A-3C30B8A080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74299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F1C98-A212-4FDB-87EE-485270A6DD90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6FA6-5C13-4166-9B2A-3C30B8A080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2933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2F1C98-A212-4FDB-87EE-485270A6DD90}" type="datetimeFigureOut">
              <a:rPr lang="it-IT" smtClean="0"/>
              <a:t>29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D66FA6-5C13-4166-9B2A-3C30B8A080B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03768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1603083" y="4092712"/>
            <a:ext cx="619268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smtClean="0">
                <a:latin typeface="Palatino Linotype" panose="02040502050505030304" pitchFamily="18" charset="0"/>
              </a:rPr>
              <a:t>Figure </a:t>
            </a:r>
            <a:r>
              <a:rPr lang="en-US" sz="1200" b="1" smtClean="0">
                <a:latin typeface="Palatino Linotype" panose="02040502050505030304" pitchFamily="18" charset="0"/>
              </a:rPr>
              <a:t>S2.</a:t>
            </a:r>
            <a:r>
              <a:rPr lang="en-US" sz="1200" smtClean="0">
                <a:latin typeface="Palatino Linotype" panose="02040502050505030304" pitchFamily="18" charset="0"/>
              </a:rPr>
              <a:t> </a:t>
            </a:r>
            <a:r>
              <a:rPr lang="en-US" sz="1200" dirty="0" smtClean="0">
                <a:latin typeface="Palatino Linotype" panose="02040502050505030304" pitchFamily="18" charset="0"/>
              </a:rPr>
              <a:t>T cell gating strategy. Gating strategy for virus-specific T cells for the analysis of AIM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 cells after stimulation with CMV-</a:t>
            </a:r>
            <a:r>
              <a:rPr lang="en-US" sz="1200" dirty="0" err="1" smtClean="0">
                <a:latin typeface="Palatino Linotype" panose="02040502050505030304" pitchFamily="18" charset="0"/>
              </a:rPr>
              <a:t>megapool</a:t>
            </a:r>
            <a:r>
              <a:rPr lang="en-US" sz="1200" dirty="0" smtClean="0">
                <a:latin typeface="Palatino Linotype" panose="02040502050505030304" pitchFamily="18" charset="0"/>
              </a:rPr>
              <a:t> used as positive control. Lymphocytes are selected on the basis of (</a:t>
            </a:r>
            <a:r>
              <a:rPr lang="en-US" sz="1200" dirty="0" err="1" smtClean="0">
                <a:latin typeface="Palatino Linotype" panose="02040502050505030304" pitchFamily="18" charset="0"/>
              </a:rPr>
              <a:t>i</a:t>
            </a:r>
            <a:r>
              <a:rPr lang="en-US" sz="1200" dirty="0" smtClean="0">
                <a:latin typeface="Palatino Linotype" panose="02040502050505030304" pitchFamily="18" charset="0"/>
              </a:rPr>
              <a:t>) size and granularity, (ii) exclusion of doublets, (iii) selection of LIVE and CD3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 cells, and (iv) CD4 or CD8 expression. Cell activation is measured as percentage of OX40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/CD137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 double-positive cells within the CD4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 T cell subset (</a:t>
            </a:r>
            <a:r>
              <a:rPr lang="en-US" sz="1200" b="1" dirty="0" smtClean="0">
                <a:latin typeface="Palatino Linotype" panose="02040502050505030304" pitchFamily="18" charset="0"/>
              </a:rPr>
              <a:t>A</a:t>
            </a:r>
            <a:r>
              <a:rPr lang="en-US" sz="1200" dirty="0" smtClean="0">
                <a:latin typeface="Palatino Linotype" panose="02040502050505030304" pitchFamily="18" charset="0"/>
              </a:rPr>
              <a:t>), and as percentage of CD69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/CD137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 double-positive cells within the CD8 T cell subset (</a:t>
            </a:r>
            <a:r>
              <a:rPr lang="en-US" sz="1200" b="1" dirty="0" smtClean="0">
                <a:latin typeface="Palatino Linotype" panose="02040502050505030304" pitchFamily="18" charset="0"/>
              </a:rPr>
              <a:t>B</a:t>
            </a:r>
            <a:r>
              <a:rPr lang="en-US" sz="1200" dirty="0" smtClean="0">
                <a:latin typeface="Palatino Linotype" panose="02040502050505030304" pitchFamily="18" charset="0"/>
              </a:rPr>
              <a:t>); DMSO stimulation is included as background control. Activated (OX40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CD137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) or (CD69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CD137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) cells were identified in the gate of CD4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 or CD8</a:t>
            </a:r>
            <a:r>
              <a:rPr lang="en-US" sz="1200" baseline="30000" dirty="0" smtClean="0">
                <a:latin typeface="Palatino Linotype" panose="02040502050505030304" pitchFamily="18" charset="0"/>
              </a:rPr>
              <a:t>+</a:t>
            </a:r>
            <a:r>
              <a:rPr lang="en-US" sz="1200" dirty="0" smtClean="0">
                <a:latin typeface="Palatino Linotype" panose="02040502050505030304" pitchFamily="18" charset="0"/>
              </a:rPr>
              <a:t> cells, respectively. </a:t>
            </a:r>
            <a:endParaRPr lang="it-IT" sz="1200" dirty="0">
              <a:latin typeface="Palatino Linotype" panose="02040502050505030304" pitchFamily="18" charset="0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1976" y="1124744"/>
            <a:ext cx="6480048" cy="2767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3099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45</Words>
  <Application>Microsoft Office PowerPoint</Application>
  <PresentationFormat>Presentazione su schermo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ia</dc:creator>
  <cp:lastModifiedBy>Maria</cp:lastModifiedBy>
  <cp:revision>4</cp:revision>
  <dcterms:created xsi:type="dcterms:W3CDTF">2023-03-29T16:21:04Z</dcterms:created>
  <dcterms:modified xsi:type="dcterms:W3CDTF">2023-04-29T09:28:52Z</dcterms:modified>
</cp:coreProperties>
</file>